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0" r:id="rId3"/>
    <p:sldId id="263" r:id="rId4"/>
    <p:sldId id="266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8" d="100"/>
          <a:sy n="68" d="100"/>
        </p:scale>
        <p:origin x="616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99FAA5-F755-4B76-934F-5B1D59F2D38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026B0FE-F7A6-45DC-B3E4-A39732814D9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09F935-F6C8-4E06-9749-A90683247F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92F0E-C826-4938-8000-4FBE79F31AC0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EB87F9-A26E-4BB4-8AC8-D233016E00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31D637-7AF2-4583-9305-1EDC444C71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DAA74-FCFC-48D3-8DB2-D49E36A41D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94393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34BC3E-3B34-46D8-BCF8-899E72C303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460FD10-3A60-404A-87E1-3C87EDBF8AB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646A39-DEB2-4EB3-981D-A7C355E20D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92F0E-C826-4938-8000-4FBE79F31AC0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CCD581-0AFF-48A6-B87E-D9AF2C2D50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CEA81E-2D98-4A0C-B0FF-E83EB171C9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DAA74-FCFC-48D3-8DB2-D49E36A41D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34743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B6E01BA-BA12-4253-877F-041D43240AF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58B818E-8DB1-4092-B6B3-1C2C0A26F78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64AA77-8448-4872-B6A0-D2B2CA4949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92F0E-C826-4938-8000-4FBE79F31AC0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2E93FC-2A89-4255-821B-28FD98B7FA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C78019-6C38-4B2D-92D3-3EA8524E05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DAA74-FCFC-48D3-8DB2-D49E36A41D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33367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53D337-0263-4DE7-A9A0-564DB20032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2B64749-3DB7-46A6-B4D1-89C09123B9B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3FD2E7-2485-4FD6-B9CB-D40D74E4DE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92F0E-C826-4938-8000-4FBE79F31AC0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B7296D-8330-4E71-A7CB-B4490AFDC5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AAD314-C315-4E62-9FD5-35EDBE2703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DAA74-FCFC-48D3-8DB2-D49E36A41D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65429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3F2A49-C20F-454D-B088-BE565F1AA2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6B80BED-F413-46FD-B410-1B97776E7C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F1A250-572F-47E3-922E-B169D870B9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92F0E-C826-4938-8000-4FBE79F31AC0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194A0F-924F-4DC0-97F1-3754B59560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083B37-8B07-4B4B-BA16-B565FB5111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DAA74-FCFC-48D3-8DB2-D49E36A41D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53899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A397F1-1A2B-47AC-B7F7-245CD1AF4A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E57C23A-CDC0-4313-BF9D-C8F602680D8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6FC2003-3537-4F2F-BE19-B72FFF64C72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FE75368-B55A-4EB9-9D92-BBA33AD572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92F0E-C826-4938-8000-4FBE79F31AC0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5C4E668-19EE-4D76-B803-0733BADC01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CF5B63B-DEB0-4815-8ABF-7635ABE43C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DAA74-FCFC-48D3-8DB2-D49E36A41D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82966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456D70-8A30-4D16-99C4-19C6A09703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F62D64E-7C06-44CA-AF96-DB5BE7600C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D24F824-6D2C-472C-9218-A9637651329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2573972-2163-431D-AD4E-3F7E282F7CC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06B8A9D-CFE5-4DD5-AE35-ADE2B600707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D55CFAF-7320-4467-BF78-D6B3FD40E0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92F0E-C826-4938-8000-4FBE79F31AC0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3339DAF-350F-4593-A23C-3B6D85C977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CD8CBD5-7E77-40EB-A028-0234D8A6B1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DAA74-FCFC-48D3-8DB2-D49E36A41D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38674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BF85EA-AFBA-489A-8831-4DD0089578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CDBA429-04FF-4555-8C65-22B1D9D95D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92F0E-C826-4938-8000-4FBE79F31AC0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18CA3C3-B2B8-4C67-9B9D-94F3B06D03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00A4523-EADC-491C-A3EC-DDBFE632FC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DAA74-FCFC-48D3-8DB2-D49E36A41D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64218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0717E0A-0C93-4597-B36B-CEE1253258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92F0E-C826-4938-8000-4FBE79F31AC0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8A4BE06-2B0B-4970-A340-63662C9E71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C8A2DD9-52BB-47C6-ACF3-D8F008D041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DAA74-FCFC-48D3-8DB2-D49E36A41D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1873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748C92-6A8A-4E23-A006-78994564BE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1E91E4A-2057-4419-87CE-A140E5B6F0C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5EBE47A-8EF7-40DF-99DB-62703AA0958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B5546DB-0D61-468A-82C2-CEAA929738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92F0E-C826-4938-8000-4FBE79F31AC0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B29945E-551B-43D3-8CF0-C0ED8F9BAC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9DD91B8-BB05-491E-8EB0-3823B39B14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DAA74-FCFC-48D3-8DB2-D49E36A41D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83288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4B1DBA-3FCF-4478-81A5-2A20B5EFE8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7AC5255-3C26-4816-B1FB-B8F42A106F5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EB6F8F0-6432-45A2-89A5-2EE9C1DE7F5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0F7F187-2555-4041-AB9C-556B1214D7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92F0E-C826-4938-8000-4FBE79F31AC0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524EA37-617D-4B9F-A333-C5DCED4A98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1336CEC-DD2D-40C5-BBC0-5ADC8E05EF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DAA74-FCFC-48D3-8DB2-D49E36A41D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36333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307900B-FAF8-441E-8AE5-30ED72E0CD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6A70F12-5557-482D-9FD5-2BD910B465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B3B554-74DB-412C-97BB-AB777AF6AD4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D92F0E-C826-4938-8000-4FBE79F31AC0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630184-72EC-41A5-ADA5-CA69D1934AB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39690E-50F2-4E6F-9D12-AD18D595E7E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5DAA74-FCFC-48D3-8DB2-D49E36A41D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22341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EFB257-A94E-4613-A535-8542C592208B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Mouse Liver Supplemental Tables 2, </a:t>
            </a:r>
            <a:r>
              <a:rPr lang="en-US"/>
              <a:t>4, 5 </a:t>
            </a:r>
            <a:endParaRPr lang="en-US" dirty="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9FEEF17-3B17-4783-82DE-5BD03BDB9A40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48849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F40530-301B-4E15-911C-93368546CC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Supplemental Table S2: Top 20 most significantly up- and down-regulated genes that showed a linear trend across all doses</a:t>
            </a:r>
            <a:endParaRPr lang="en-US" sz="2000" dirty="0"/>
          </a:p>
        </p:txBody>
      </p:sp>
      <p:graphicFrame>
        <p:nvGraphicFramePr>
          <p:cNvPr id="7" name="Content Placeholder 6">
            <a:extLst>
              <a:ext uri="{FF2B5EF4-FFF2-40B4-BE49-F238E27FC236}">
                <a16:creationId xmlns:a16="http://schemas.microsoft.com/office/drawing/2014/main" id="{69DC51D5-AE64-4723-A9E6-844D75210476}"/>
              </a:ext>
            </a:extLst>
          </p:cNvPr>
          <p:cNvGraphicFramePr>
            <a:graphicFrameLocks noGrp="1"/>
          </p:cNvGraphicFramePr>
          <p:nvPr>
            <p:ph sz="half" idx="1"/>
          </p:nvPr>
        </p:nvGraphicFramePr>
        <p:xfrm>
          <a:off x="314325" y="1478827"/>
          <a:ext cx="5181599" cy="3101832"/>
        </p:xfrm>
        <a:graphic>
          <a:graphicData uri="http://schemas.openxmlformats.org/drawingml/2006/table">
            <a:tbl>
              <a:tblPr firstRow="1">
                <a:tableStyleId>{9D7B26C5-4107-4FEC-AEDC-1716B250A1EF}</a:tableStyleId>
              </a:tblPr>
              <a:tblGrid>
                <a:gridCol w="926983">
                  <a:extLst>
                    <a:ext uri="{9D8B030D-6E8A-4147-A177-3AD203B41FA5}">
                      <a16:colId xmlns:a16="http://schemas.microsoft.com/office/drawing/2014/main" val="2991647486"/>
                    </a:ext>
                  </a:extLst>
                </a:gridCol>
                <a:gridCol w="1770776">
                  <a:extLst>
                    <a:ext uri="{9D8B030D-6E8A-4147-A177-3AD203B41FA5}">
                      <a16:colId xmlns:a16="http://schemas.microsoft.com/office/drawing/2014/main" val="3918192837"/>
                    </a:ext>
                  </a:extLst>
                </a:gridCol>
                <a:gridCol w="772486">
                  <a:extLst>
                    <a:ext uri="{9D8B030D-6E8A-4147-A177-3AD203B41FA5}">
                      <a16:colId xmlns:a16="http://schemas.microsoft.com/office/drawing/2014/main" val="2382363508"/>
                    </a:ext>
                  </a:extLst>
                </a:gridCol>
                <a:gridCol w="820024">
                  <a:extLst>
                    <a:ext uri="{9D8B030D-6E8A-4147-A177-3AD203B41FA5}">
                      <a16:colId xmlns:a16="http://schemas.microsoft.com/office/drawing/2014/main" val="941481225"/>
                    </a:ext>
                  </a:extLst>
                </a:gridCol>
                <a:gridCol w="891330">
                  <a:extLst>
                    <a:ext uri="{9D8B030D-6E8A-4147-A177-3AD203B41FA5}">
                      <a16:colId xmlns:a16="http://schemas.microsoft.com/office/drawing/2014/main" val="850615458"/>
                    </a:ext>
                  </a:extLst>
                </a:gridCol>
              </a:tblGrid>
              <a:tr h="172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Gene Symbol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SystematicNam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adj.P.Val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B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logFC_adjusted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extLst>
                  <a:ext uri="{0D108BD9-81ED-4DB2-BD59-A6C34878D82A}">
                    <a16:rowId xmlns:a16="http://schemas.microsoft.com/office/drawing/2014/main" val="1449099493"/>
                  </a:ext>
                </a:extLst>
              </a:tr>
              <a:tr h="172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Cdkn1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NM_00766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05E-0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9.1812858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4.56685304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extLst>
                  <a:ext uri="{0D108BD9-81ED-4DB2-BD59-A6C34878D82A}">
                    <a16:rowId xmlns:a16="http://schemas.microsoft.com/office/drawing/2014/main" val="3872177270"/>
                  </a:ext>
                </a:extLst>
              </a:tr>
              <a:tr h="172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Gm4594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XR_38138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6.42E-1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9.7599563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3.66682981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extLst>
                  <a:ext uri="{0D108BD9-81ED-4DB2-BD59-A6C34878D82A}">
                    <a16:rowId xmlns:a16="http://schemas.microsoft.com/office/drawing/2014/main" val="4238394960"/>
                  </a:ext>
                </a:extLst>
              </a:tr>
              <a:tr h="172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Abca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ENSMUST0000012649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01887808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-0.94513706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3.63663617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extLst>
                  <a:ext uri="{0D108BD9-81ED-4DB2-BD59-A6C34878D82A}">
                    <a16:rowId xmlns:a16="http://schemas.microsoft.com/office/drawing/2014/main" val="2092438593"/>
                  </a:ext>
                </a:extLst>
              </a:tr>
              <a:tr h="172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Gtf3c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ENSMUST0000020582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00143914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2.28092830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3.55900522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extLst>
                  <a:ext uri="{0D108BD9-81ED-4DB2-BD59-A6C34878D82A}">
                    <a16:rowId xmlns:a16="http://schemas.microsoft.com/office/drawing/2014/main" val="2672462293"/>
                  </a:ext>
                </a:extLst>
              </a:tr>
              <a:tr h="172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Rbm2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NM_00108142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00826809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11184388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3.55689387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extLst>
                  <a:ext uri="{0D108BD9-81ED-4DB2-BD59-A6C34878D82A}">
                    <a16:rowId xmlns:a16="http://schemas.microsoft.com/office/drawing/2014/main" val="1154008003"/>
                  </a:ext>
                </a:extLst>
              </a:tr>
              <a:tr h="172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Gria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NM_01688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3.25E-1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26.7467656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3.23230693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extLst>
                  <a:ext uri="{0D108BD9-81ED-4DB2-BD59-A6C34878D82A}">
                    <a16:rowId xmlns:a16="http://schemas.microsoft.com/office/drawing/2014/main" val="3972363750"/>
                  </a:ext>
                </a:extLst>
              </a:tr>
              <a:tr h="172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Eda2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NM_00116143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9.69E-0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8.4860939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3.18877085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extLst>
                  <a:ext uri="{0D108BD9-81ED-4DB2-BD59-A6C34878D82A}">
                    <a16:rowId xmlns:a16="http://schemas.microsoft.com/office/drawing/2014/main" val="4219119646"/>
                  </a:ext>
                </a:extLst>
              </a:tr>
              <a:tr h="172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Phlda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NM_01375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2.16E-1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30.2921277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3.03839700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extLst>
                  <a:ext uri="{0D108BD9-81ED-4DB2-BD59-A6C34878D82A}">
                    <a16:rowId xmlns:a16="http://schemas.microsoft.com/office/drawing/2014/main" val="762878985"/>
                  </a:ext>
                </a:extLst>
              </a:tr>
              <a:tr h="172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Atp8b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NM_17719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2.80E-1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20.8086203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2.93255464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extLst>
                  <a:ext uri="{0D108BD9-81ED-4DB2-BD59-A6C34878D82A}">
                    <a16:rowId xmlns:a16="http://schemas.microsoft.com/office/drawing/2014/main" val="17969731"/>
                  </a:ext>
                </a:extLst>
              </a:tr>
              <a:tr h="172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Ddia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NM_00108099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15E-0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9.0305880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2.68976308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extLst>
                  <a:ext uri="{0D108BD9-81ED-4DB2-BD59-A6C34878D82A}">
                    <a16:rowId xmlns:a16="http://schemas.microsoft.com/office/drawing/2014/main" val="2429949334"/>
                  </a:ext>
                </a:extLst>
              </a:tr>
              <a:tr h="172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Plin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NM_02056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6.12E-0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1.8241308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2.58571699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extLst>
                  <a:ext uri="{0D108BD9-81ED-4DB2-BD59-A6C34878D82A}">
                    <a16:rowId xmlns:a16="http://schemas.microsoft.com/office/drawing/2014/main" val="560818832"/>
                  </a:ext>
                </a:extLst>
              </a:tr>
              <a:tr h="172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Gm4157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XR_87675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02297525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-1.20847478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2.51619957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extLst>
                  <a:ext uri="{0D108BD9-81ED-4DB2-BD59-A6C34878D82A}">
                    <a16:rowId xmlns:a16="http://schemas.microsoft.com/office/drawing/2014/main" val="2475950965"/>
                  </a:ext>
                </a:extLst>
              </a:tr>
              <a:tr h="172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Adgrl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ENSMUST0000014035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01274396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-0.43779262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2.43457978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extLst>
                  <a:ext uri="{0D108BD9-81ED-4DB2-BD59-A6C34878D82A}">
                    <a16:rowId xmlns:a16="http://schemas.microsoft.com/office/drawing/2014/main" val="2000223722"/>
                  </a:ext>
                </a:extLst>
              </a:tr>
              <a:tr h="172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Gria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ENSMUST0000012819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8.67E-0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1.4215111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2.42746574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extLst>
                  <a:ext uri="{0D108BD9-81ED-4DB2-BD59-A6C34878D82A}">
                    <a16:rowId xmlns:a16="http://schemas.microsoft.com/office/drawing/2014/main" val="4223744636"/>
                  </a:ext>
                </a:extLst>
              </a:tr>
              <a:tr h="172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Mybl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NM_00865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6.57E-0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7.0904713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2.41865013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extLst>
                  <a:ext uri="{0D108BD9-81ED-4DB2-BD59-A6C34878D82A}">
                    <a16:rowId xmlns:a16="http://schemas.microsoft.com/office/drawing/2014/main" val="1575326602"/>
                  </a:ext>
                </a:extLst>
              </a:tr>
              <a:tr h="172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Gm3933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AK07927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00218982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73981150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2.41431425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extLst>
                  <a:ext uri="{0D108BD9-81ED-4DB2-BD59-A6C34878D82A}">
                    <a16:rowId xmlns:a16="http://schemas.microsoft.com/office/drawing/2014/main" val="488887187"/>
                  </a:ext>
                </a:extLst>
              </a:tr>
              <a:tr h="172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Gadd45b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NM_00865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2.94E-0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8.018211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dirty="0">
                          <a:effectLst/>
                        </a:rPr>
                        <a:t>2.36907336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extLst>
                  <a:ext uri="{0D108BD9-81ED-4DB2-BD59-A6C34878D82A}">
                    <a16:rowId xmlns:a16="http://schemas.microsoft.com/office/drawing/2014/main" val="2458715658"/>
                  </a:ext>
                </a:extLst>
              </a:tr>
            </a:tbl>
          </a:graphicData>
        </a:graphic>
      </p:graphicFrame>
      <p:graphicFrame>
        <p:nvGraphicFramePr>
          <p:cNvPr id="5" name="Content Placeholder 4">
            <a:extLst>
              <a:ext uri="{FF2B5EF4-FFF2-40B4-BE49-F238E27FC236}">
                <a16:creationId xmlns:a16="http://schemas.microsoft.com/office/drawing/2014/main" id="{51BD1CBA-527D-4EB2-924C-428621234163}"/>
              </a:ext>
            </a:extLst>
          </p:cNvPr>
          <p:cNvGraphicFramePr>
            <a:graphicFrameLocks noGrp="1"/>
          </p:cNvGraphicFramePr>
          <p:nvPr>
            <p:ph sz="half" idx="2"/>
          </p:nvPr>
        </p:nvGraphicFramePr>
        <p:xfrm>
          <a:off x="5761074" y="1478827"/>
          <a:ext cx="5181599" cy="3101832"/>
        </p:xfrm>
        <a:graphic>
          <a:graphicData uri="http://schemas.openxmlformats.org/drawingml/2006/table">
            <a:tbl>
              <a:tblPr firstRow="1">
                <a:tableStyleId>{9D7B26C5-4107-4FEC-AEDC-1716B250A1EF}</a:tableStyleId>
              </a:tblPr>
              <a:tblGrid>
                <a:gridCol w="926983">
                  <a:extLst>
                    <a:ext uri="{9D8B030D-6E8A-4147-A177-3AD203B41FA5}">
                      <a16:colId xmlns:a16="http://schemas.microsoft.com/office/drawing/2014/main" val="277486104"/>
                    </a:ext>
                  </a:extLst>
                </a:gridCol>
                <a:gridCol w="1770776">
                  <a:extLst>
                    <a:ext uri="{9D8B030D-6E8A-4147-A177-3AD203B41FA5}">
                      <a16:colId xmlns:a16="http://schemas.microsoft.com/office/drawing/2014/main" val="3218545639"/>
                    </a:ext>
                  </a:extLst>
                </a:gridCol>
                <a:gridCol w="772486">
                  <a:extLst>
                    <a:ext uri="{9D8B030D-6E8A-4147-A177-3AD203B41FA5}">
                      <a16:colId xmlns:a16="http://schemas.microsoft.com/office/drawing/2014/main" val="2036818648"/>
                    </a:ext>
                  </a:extLst>
                </a:gridCol>
                <a:gridCol w="820024">
                  <a:extLst>
                    <a:ext uri="{9D8B030D-6E8A-4147-A177-3AD203B41FA5}">
                      <a16:colId xmlns:a16="http://schemas.microsoft.com/office/drawing/2014/main" val="2215612414"/>
                    </a:ext>
                  </a:extLst>
                </a:gridCol>
                <a:gridCol w="891330">
                  <a:extLst>
                    <a:ext uri="{9D8B030D-6E8A-4147-A177-3AD203B41FA5}">
                      <a16:colId xmlns:a16="http://schemas.microsoft.com/office/drawing/2014/main" val="1808637835"/>
                    </a:ext>
                  </a:extLst>
                </a:gridCol>
              </a:tblGrid>
              <a:tr h="172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Gene Symbol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SystematicNam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adj.P.Val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B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logFC_adjusted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extLst>
                  <a:ext uri="{0D108BD9-81ED-4DB2-BD59-A6C34878D82A}">
                    <a16:rowId xmlns:a16="http://schemas.microsoft.com/office/drawing/2014/main" val="240728735"/>
                  </a:ext>
                </a:extLst>
              </a:tr>
              <a:tr h="172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Hbb-bt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NM_00822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2.71E-0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0.0376662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-7.17896740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extLst>
                  <a:ext uri="{0D108BD9-81ED-4DB2-BD59-A6C34878D82A}">
                    <a16:rowId xmlns:a16="http://schemas.microsoft.com/office/drawing/2014/main" val="302881252"/>
                  </a:ext>
                </a:extLst>
              </a:tr>
              <a:tr h="172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Hbb-b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NM_00127816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4.19E-0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9.50286831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-5.33605404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extLst>
                  <a:ext uri="{0D108BD9-81ED-4DB2-BD59-A6C34878D82A}">
                    <a16:rowId xmlns:a16="http://schemas.microsoft.com/office/drawing/2014/main" val="3057147180"/>
                  </a:ext>
                </a:extLst>
              </a:tr>
              <a:tr h="172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Hbb-b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NM_01695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85E-0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7.63078265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-5.19830837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extLst>
                  <a:ext uri="{0D108BD9-81ED-4DB2-BD59-A6C34878D82A}">
                    <a16:rowId xmlns:a16="http://schemas.microsoft.com/office/drawing/2014/main" val="2517200406"/>
                  </a:ext>
                </a:extLst>
              </a:tr>
              <a:tr h="172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Serpina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NM_02799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39E-0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8.8178893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-5.05329287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extLst>
                  <a:ext uri="{0D108BD9-81ED-4DB2-BD59-A6C34878D82A}">
                    <a16:rowId xmlns:a16="http://schemas.microsoft.com/office/drawing/2014/main" val="1516092610"/>
                  </a:ext>
                </a:extLst>
              </a:tr>
              <a:tr h="172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Hba-a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NM_00108395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6.00E-0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9.08869292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-4.68573891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extLst>
                  <a:ext uri="{0D108BD9-81ED-4DB2-BD59-A6C34878D82A}">
                    <a16:rowId xmlns:a16="http://schemas.microsoft.com/office/drawing/2014/main" val="967096473"/>
                  </a:ext>
                </a:extLst>
              </a:tr>
              <a:tr h="172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Hba-a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NM_00821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9.06E-0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8.56831299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-4.68545816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extLst>
                  <a:ext uri="{0D108BD9-81ED-4DB2-BD59-A6C34878D82A}">
                    <a16:rowId xmlns:a16="http://schemas.microsoft.com/office/drawing/2014/main" val="4266466374"/>
                  </a:ext>
                </a:extLst>
              </a:tr>
              <a:tr h="172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Hba-a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NM_00821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5.01E-0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9.32467141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-4.68138133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extLst>
                  <a:ext uri="{0D108BD9-81ED-4DB2-BD59-A6C34878D82A}">
                    <a16:rowId xmlns:a16="http://schemas.microsoft.com/office/drawing/2014/main" val="1993212948"/>
                  </a:ext>
                </a:extLst>
              </a:tr>
              <a:tr h="172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Ms4a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NM_00764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8.48E-0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6.6794523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-4.12895298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extLst>
                  <a:ext uri="{0D108BD9-81ED-4DB2-BD59-A6C34878D82A}">
                    <a16:rowId xmlns:a16="http://schemas.microsoft.com/office/drawing/2014/main" val="4162581450"/>
                  </a:ext>
                </a:extLst>
              </a:tr>
              <a:tr h="172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Fcm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NM_02697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85E-0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7.6374400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-3.50318796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extLst>
                  <a:ext uri="{0D108BD9-81ED-4DB2-BD59-A6C34878D82A}">
                    <a16:rowId xmlns:a16="http://schemas.microsoft.com/office/drawing/2014/main" val="3280928880"/>
                  </a:ext>
                </a:extLst>
              </a:tr>
              <a:tr h="172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Hsd3b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NM_00829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65E-0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7.77682149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-3.42101362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extLst>
                  <a:ext uri="{0D108BD9-81ED-4DB2-BD59-A6C34878D82A}">
                    <a16:rowId xmlns:a16="http://schemas.microsoft.com/office/drawing/2014/main" val="2393063078"/>
                  </a:ext>
                </a:extLst>
              </a:tr>
              <a:tr h="172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Serpina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NM_02799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00014678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5.09886396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-3.39285032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extLst>
                  <a:ext uri="{0D108BD9-81ED-4DB2-BD59-A6C34878D82A}">
                    <a16:rowId xmlns:a16="http://schemas.microsoft.com/office/drawing/2014/main" val="358220299"/>
                  </a:ext>
                </a:extLst>
              </a:tr>
              <a:tr h="172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Cd1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NM_00984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3.25E-0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9.815517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-3.10885981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extLst>
                  <a:ext uri="{0D108BD9-81ED-4DB2-BD59-A6C34878D82A}">
                    <a16:rowId xmlns:a16="http://schemas.microsoft.com/office/drawing/2014/main" val="3525876207"/>
                  </a:ext>
                </a:extLst>
              </a:tr>
              <a:tr h="172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Chil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NM_00989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6.69E-0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8.948953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-2.92208910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extLst>
                  <a:ext uri="{0D108BD9-81ED-4DB2-BD59-A6C34878D82A}">
                    <a16:rowId xmlns:a16="http://schemas.microsoft.com/office/drawing/2014/main" val="2349895684"/>
                  </a:ext>
                </a:extLst>
              </a:tr>
              <a:tr h="172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Cd1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NM_00984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00018587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4.76660452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-2.88847461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extLst>
                  <a:ext uri="{0D108BD9-81ED-4DB2-BD59-A6C34878D82A}">
                    <a16:rowId xmlns:a16="http://schemas.microsoft.com/office/drawing/2014/main" val="3477926090"/>
                  </a:ext>
                </a:extLst>
              </a:tr>
              <a:tr h="172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Top2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NM_01162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00034386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4.02501741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-2.85475775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extLst>
                  <a:ext uri="{0D108BD9-81ED-4DB2-BD59-A6C34878D82A}">
                    <a16:rowId xmlns:a16="http://schemas.microsoft.com/office/drawing/2014/main" val="515131338"/>
                  </a:ext>
                </a:extLst>
              </a:tr>
              <a:tr h="172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Pou2af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NM_01113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46E-0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7.94903169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-2.82920332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extLst>
                  <a:ext uri="{0D108BD9-81ED-4DB2-BD59-A6C34878D82A}">
                    <a16:rowId xmlns:a16="http://schemas.microsoft.com/office/drawing/2014/main" val="40888591"/>
                  </a:ext>
                </a:extLst>
              </a:tr>
              <a:tr h="17232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H2-Ab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NM_20710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7.04E-1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9.6006623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dirty="0">
                          <a:effectLst/>
                        </a:rPr>
                        <a:t>-2.80993969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42" marR="5942" marT="5942" marB="0" anchor="b"/>
                </a:tc>
                <a:extLst>
                  <a:ext uri="{0D108BD9-81ED-4DB2-BD59-A6C34878D82A}">
                    <a16:rowId xmlns:a16="http://schemas.microsoft.com/office/drawing/2014/main" val="3191884191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6494DC4C-D20F-4ED4-A490-015D398456BA}"/>
              </a:ext>
            </a:extLst>
          </p:cNvPr>
          <p:cNvSpPr txBox="1"/>
          <p:nvPr/>
        </p:nvSpPr>
        <p:spPr>
          <a:xfrm>
            <a:off x="247454" y="4826675"/>
            <a:ext cx="11106346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Supplemental Table S2: Top 20 most significantly up- and down-regulated mRNAs that showed a linear trend across all doses. Tables of up-regulated (A) and down-regulated (B) linear, or dose-responsive, mRNAs. Gene symbol, systematic name, </a:t>
            </a:r>
            <a:r>
              <a:rPr lang="en-US" dirty="0" err="1"/>
              <a:t>Benjamini</a:t>
            </a:r>
            <a:r>
              <a:rPr lang="en-US" dirty="0"/>
              <a:t>-Hochberg adjusted p-value, B statistic, and the average log2FC across all doses are shown in each table. Genes are listed in order of decreasing significance.</a:t>
            </a:r>
          </a:p>
        </p:txBody>
      </p:sp>
    </p:spTree>
    <p:extLst>
      <p:ext uri="{BB962C8B-B14F-4D97-AF65-F5344CB8AC3E}">
        <p14:creationId xmlns:p14="http://schemas.microsoft.com/office/powerpoint/2010/main" val="262821121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1AB9B6-B29B-41DF-905E-6A8BC8DA0C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Supplemental Table S4: MiRNAs that showed a linear trend</a:t>
            </a:r>
            <a:endParaRPr lang="en-US" sz="2000" dirty="0"/>
          </a:p>
        </p:txBody>
      </p:sp>
      <p:graphicFrame>
        <p:nvGraphicFramePr>
          <p:cNvPr id="5" name="Content Placeholder 4">
            <a:extLst>
              <a:ext uri="{FF2B5EF4-FFF2-40B4-BE49-F238E27FC236}">
                <a16:creationId xmlns:a16="http://schemas.microsoft.com/office/drawing/2014/main" id="{0B476C00-AE85-43E6-BEF4-29B8CF5E2114}"/>
              </a:ext>
            </a:extLst>
          </p:cNvPr>
          <p:cNvGraphicFramePr>
            <a:graphicFrameLocks noGrp="1"/>
          </p:cNvGraphicFramePr>
          <p:nvPr>
            <p:ph sz="half" idx="1"/>
            <p:extLst>
              <p:ext uri="{D42A27DB-BD31-4B8C-83A1-F6EECF244321}">
                <p14:modId xmlns:p14="http://schemas.microsoft.com/office/powerpoint/2010/main" val="1647350992"/>
              </p:ext>
            </p:extLst>
          </p:nvPr>
        </p:nvGraphicFramePr>
        <p:xfrm>
          <a:off x="3133824" y="1576256"/>
          <a:ext cx="5181600" cy="2978856"/>
        </p:xfrm>
        <a:graphic>
          <a:graphicData uri="http://schemas.openxmlformats.org/drawingml/2006/table">
            <a:tbl>
              <a:tblPr firstRow="1">
                <a:tableStyleId>{9D7B26C5-4107-4FEC-AEDC-1716B250A1EF}</a:tableStyleId>
              </a:tblPr>
              <a:tblGrid>
                <a:gridCol w="947297">
                  <a:extLst>
                    <a:ext uri="{9D8B030D-6E8A-4147-A177-3AD203B41FA5}">
                      <a16:colId xmlns:a16="http://schemas.microsoft.com/office/drawing/2014/main" val="1656313392"/>
                    </a:ext>
                  </a:extLst>
                </a:gridCol>
                <a:gridCol w="1757635">
                  <a:extLst>
                    <a:ext uri="{9D8B030D-6E8A-4147-A177-3AD203B41FA5}">
                      <a16:colId xmlns:a16="http://schemas.microsoft.com/office/drawing/2014/main" val="51986813"/>
                    </a:ext>
                  </a:extLst>
                </a:gridCol>
                <a:gridCol w="741859">
                  <a:extLst>
                    <a:ext uri="{9D8B030D-6E8A-4147-A177-3AD203B41FA5}">
                      <a16:colId xmlns:a16="http://schemas.microsoft.com/office/drawing/2014/main" val="467045530"/>
                    </a:ext>
                  </a:extLst>
                </a:gridCol>
                <a:gridCol w="741859">
                  <a:extLst>
                    <a:ext uri="{9D8B030D-6E8A-4147-A177-3AD203B41FA5}">
                      <a16:colId xmlns:a16="http://schemas.microsoft.com/office/drawing/2014/main" val="3502558714"/>
                    </a:ext>
                  </a:extLst>
                </a:gridCol>
                <a:gridCol w="992950">
                  <a:extLst>
                    <a:ext uri="{9D8B030D-6E8A-4147-A177-3AD203B41FA5}">
                      <a16:colId xmlns:a16="http://schemas.microsoft.com/office/drawing/2014/main" val="3814325616"/>
                    </a:ext>
                  </a:extLst>
                </a:gridCol>
              </a:tblGrid>
              <a:tr h="16549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Agilent ID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 err="1">
                          <a:effectLst/>
                        </a:rPr>
                        <a:t>SystematicNam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adj.P.Val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B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logFC_adjusted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extLst>
                  <a:ext uri="{0D108BD9-81ED-4DB2-BD59-A6C34878D82A}">
                    <a16:rowId xmlns:a16="http://schemas.microsoft.com/office/drawing/2014/main" val="1527298955"/>
                  </a:ext>
                </a:extLst>
              </a:tr>
              <a:tr h="16549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A_54_P0000506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mmu-miR-3102-5p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4.29E-0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1.4337309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2.44861701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extLst>
                  <a:ext uri="{0D108BD9-81ED-4DB2-BD59-A6C34878D82A}">
                    <a16:rowId xmlns:a16="http://schemas.microsoft.com/office/drawing/2014/main" val="2642552693"/>
                  </a:ext>
                </a:extLst>
              </a:tr>
              <a:tr h="16549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A_54_P0000506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mmu-miR-3102-5p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12E-0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9.83707042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2.40027759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extLst>
                  <a:ext uri="{0D108BD9-81ED-4DB2-BD59-A6C34878D82A}">
                    <a16:rowId xmlns:a16="http://schemas.microsoft.com/office/drawing/2014/main" val="1559632778"/>
                  </a:ext>
                </a:extLst>
              </a:tr>
              <a:tr h="16549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A_54_P249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mmu-miR-34a-5p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2.88E-0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2.4899024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62227503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extLst>
                  <a:ext uri="{0D108BD9-81ED-4DB2-BD59-A6C34878D82A}">
                    <a16:rowId xmlns:a16="http://schemas.microsoft.com/office/drawing/2014/main" val="879616531"/>
                  </a:ext>
                </a:extLst>
              </a:tr>
              <a:tr h="16549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A_54_P0000562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mmu-miR-396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00027808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6.51915892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49470313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extLst>
                  <a:ext uri="{0D108BD9-81ED-4DB2-BD59-A6C34878D82A}">
                    <a16:rowId xmlns:a16="http://schemas.microsoft.com/office/drawing/2014/main" val="466161887"/>
                  </a:ext>
                </a:extLst>
              </a:tr>
              <a:tr h="16549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A_54_P0000526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mmu-miR-211-3p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01594119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6504746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43102148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extLst>
                  <a:ext uri="{0D108BD9-81ED-4DB2-BD59-A6C34878D82A}">
                    <a16:rowId xmlns:a16="http://schemas.microsoft.com/office/drawing/2014/main" val="1137678513"/>
                  </a:ext>
                </a:extLst>
              </a:tr>
              <a:tr h="16549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A_54_P0000562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mmu-miR-396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00064528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5.38449028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41223965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extLst>
                  <a:ext uri="{0D108BD9-81ED-4DB2-BD59-A6C34878D82A}">
                    <a16:rowId xmlns:a16="http://schemas.microsoft.com/office/drawing/2014/main" val="4117898747"/>
                  </a:ext>
                </a:extLst>
              </a:tr>
              <a:tr h="16549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A_54_P0000562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mmu-miR-512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00040274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5.98662976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35631498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extLst>
                  <a:ext uri="{0D108BD9-81ED-4DB2-BD59-A6C34878D82A}">
                    <a16:rowId xmlns:a16="http://schemas.microsoft.com/office/drawing/2014/main" val="3142867337"/>
                  </a:ext>
                </a:extLst>
              </a:tr>
              <a:tr h="16549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A_54_P0000562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mmu-miR-512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00127603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4.60063464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32101498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extLst>
                  <a:ext uri="{0D108BD9-81ED-4DB2-BD59-A6C34878D82A}">
                    <a16:rowId xmlns:a16="http://schemas.microsoft.com/office/drawing/2014/main" val="3560309036"/>
                  </a:ext>
                </a:extLst>
              </a:tr>
              <a:tr h="16549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A_54_P0000525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mmu-miR-211-3p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02104961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16074096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2462281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extLst>
                  <a:ext uri="{0D108BD9-81ED-4DB2-BD59-A6C34878D82A}">
                    <a16:rowId xmlns:a16="http://schemas.microsoft.com/office/drawing/2014/main" val="30393267"/>
                  </a:ext>
                </a:extLst>
              </a:tr>
              <a:tr h="16549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A_54_P249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mmu-miR-34a-5p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8.57E-0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0.3724115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12655241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extLst>
                  <a:ext uri="{0D108BD9-81ED-4DB2-BD59-A6C34878D82A}">
                    <a16:rowId xmlns:a16="http://schemas.microsoft.com/office/drawing/2014/main" val="3595305205"/>
                  </a:ext>
                </a:extLst>
              </a:tr>
              <a:tr h="16549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A_54_P0000648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mmu-miR-811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02104961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95751621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12613526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extLst>
                  <a:ext uri="{0D108BD9-81ED-4DB2-BD59-A6C34878D82A}">
                    <a16:rowId xmlns:a16="http://schemas.microsoft.com/office/drawing/2014/main" val="2401433380"/>
                  </a:ext>
                </a:extLst>
              </a:tr>
              <a:tr h="16549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A_54_P0000648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mmu-miR-811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03766008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24962473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05740790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extLst>
                  <a:ext uri="{0D108BD9-81ED-4DB2-BD59-A6C34878D82A}">
                    <a16:rowId xmlns:a16="http://schemas.microsoft.com/office/drawing/2014/main" val="1890514707"/>
                  </a:ext>
                </a:extLst>
              </a:tr>
              <a:tr h="16549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A_54_P262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mmu-miR-223-3p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02686337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68454336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-1.0281028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extLst>
                  <a:ext uri="{0D108BD9-81ED-4DB2-BD59-A6C34878D82A}">
                    <a16:rowId xmlns:a16="http://schemas.microsoft.com/office/drawing/2014/main" val="310773864"/>
                  </a:ext>
                </a:extLst>
              </a:tr>
              <a:tr h="16549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A_54_P257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mmu-miR-342-3p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00391637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3.22000728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-1.08394356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extLst>
                  <a:ext uri="{0D108BD9-81ED-4DB2-BD59-A6C34878D82A}">
                    <a16:rowId xmlns:a16="http://schemas.microsoft.com/office/drawing/2014/main" val="467626384"/>
                  </a:ext>
                </a:extLst>
              </a:tr>
              <a:tr h="16549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A_54_P437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mmu-miR-142a-5p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04490541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03595939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-1.10130387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extLst>
                  <a:ext uri="{0D108BD9-81ED-4DB2-BD59-A6C34878D82A}">
                    <a16:rowId xmlns:a16="http://schemas.microsoft.com/office/drawing/2014/main" val="953035887"/>
                  </a:ext>
                </a:extLst>
              </a:tr>
              <a:tr h="16549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A_54_P257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mmu-miR-342-3p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00323058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3.49555219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-1.31677770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extLst>
                  <a:ext uri="{0D108BD9-81ED-4DB2-BD59-A6C34878D82A}">
                    <a16:rowId xmlns:a16="http://schemas.microsoft.com/office/drawing/2014/main" val="1083528404"/>
                  </a:ext>
                </a:extLst>
              </a:tr>
              <a:tr h="16549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A_54_P369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mmu-miR-142a-3p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01187137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2.07783484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dirty="0">
                          <a:effectLst/>
                        </a:rPr>
                        <a:t>-1.45817206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707" marR="5707" marT="5707" marB="0" anchor="b"/>
                </a:tc>
                <a:extLst>
                  <a:ext uri="{0D108BD9-81ED-4DB2-BD59-A6C34878D82A}">
                    <a16:rowId xmlns:a16="http://schemas.microsoft.com/office/drawing/2014/main" val="1111289240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B5426AED-9763-4652-9691-6760DBDE7657}"/>
              </a:ext>
            </a:extLst>
          </p:cNvPr>
          <p:cNvSpPr txBox="1"/>
          <p:nvPr/>
        </p:nvSpPr>
        <p:spPr>
          <a:xfrm>
            <a:off x="256880" y="4826675"/>
            <a:ext cx="11771721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Supplemental Table S4: Top 20 most significant miRNAs that showed a linear trend across all doses. Table of up-regulated linear, or dose-responsive, miRNAs. Probe Name, Systematic name, </a:t>
            </a:r>
            <a:r>
              <a:rPr lang="en-US" dirty="0" err="1"/>
              <a:t>Benjamini</a:t>
            </a:r>
            <a:r>
              <a:rPr lang="en-US" dirty="0"/>
              <a:t>-Hochberg adjusted p-value, B statistic, and the average log2FC across all doses are shown in each table. </a:t>
            </a:r>
          </a:p>
        </p:txBody>
      </p:sp>
    </p:spTree>
    <p:extLst>
      <p:ext uri="{BB962C8B-B14F-4D97-AF65-F5344CB8AC3E}">
        <p14:creationId xmlns:p14="http://schemas.microsoft.com/office/powerpoint/2010/main" val="175796626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BD08D9-03B9-46A0-9215-5C5680083F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Supplemental Table S5: Significantly up- and down-regulated </a:t>
            </a:r>
            <a:r>
              <a:rPr lang="en-US" sz="2000" dirty="0" err="1">
                <a:latin typeface="Arial" panose="020B0604020202020204" pitchFamily="34" charset="0"/>
                <a:cs typeface="Arial" panose="020B0604020202020204" pitchFamily="34" charset="0"/>
              </a:rPr>
              <a:t>lncRNAs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that showed a linear trend across all doses</a:t>
            </a:r>
            <a:endParaRPr lang="en-US" sz="2000" dirty="0"/>
          </a:p>
        </p:txBody>
      </p:sp>
      <p:graphicFrame>
        <p:nvGraphicFramePr>
          <p:cNvPr id="5" name="Content Placeholder 4">
            <a:extLst>
              <a:ext uri="{FF2B5EF4-FFF2-40B4-BE49-F238E27FC236}">
                <a16:creationId xmlns:a16="http://schemas.microsoft.com/office/drawing/2014/main" id="{17E638D3-D101-4217-A2AB-60746E5CC41F}"/>
              </a:ext>
            </a:extLst>
          </p:cNvPr>
          <p:cNvGraphicFramePr>
            <a:graphicFrameLocks noGrp="1"/>
          </p:cNvGraphicFramePr>
          <p:nvPr>
            <p:ph sz="half" idx="1"/>
            <p:extLst>
              <p:ext uri="{D42A27DB-BD31-4B8C-83A1-F6EECF244321}">
                <p14:modId xmlns:p14="http://schemas.microsoft.com/office/powerpoint/2010/main" val="3404398334"/>
              </p:ext>
            </p:extLst>
          </p:nvPr>
        </p:nvGraphicFramePr>
        <p:xfrm>
          <a:off x="2716350" y="1352109"/>
          <a:ext cx="6087387" cy="3954742"/>
        </p:xfrm>
        <a:graphic>
          <a:graphicData uri="http://schemas.openxmlformats.org/drawingml/2006/table">
            <a:tbl>
              <a:tblPr firstRow="1">
                <a:tableStyleId>{9D7B26C5-4107-4FEC-AEDC-1716B250A1EF}</a:tableStyleId>
              </a:tblPr>
              <a:tblGrid>
                <a:gridCol w="1462224">
                  <a:extLst>
                    <a:ext uri="{9D8B030D-6E8A-4147-A177-3AD203B41FA5}">
                      <a16:colId xmlns:a16="http://schemas.microsoft.com/office/drawing/2014/main" val="2272559810"/>
                    </a:ext>
                  </a:extLst>
                </a:gridCol>
                <a:gridCol w="1913768">
                  <a:extLst>
                    <a:ext uri="{9D8B030D-6E8A-4147-A177-3AD203B41FA5}">
                      <a16:colId xmlns:a16="http://schemas.microsoft.com/office/drawing/2014/main" val="659985225"/>
                    </a:ext>
                  </a:extLst>
                </a:gridCol>
                <a:gridCol w="1041621">
                  <a:extLst>
                    <a:ext uri="{9D8B030D-6E8A-4147-A177-3AD203B41FA5}">
                      <a16:colId xmlns:a16="http://schemas.microsoft.com/office/drawing/2014/main" val="1100463737"/>
                    </a:ext>
                  </a:extLst>
                </a:gridCol>
                <a:gridCol w="842838">
                  <a:extLst>
                    <a:ext uri="{9D8B030D-6E8A-4147-A177-3AD203B41FA5}">
                      <a16:colId xmlns:a16="http://schemas.microsoft.com/office/drawing/2014/main" val="1074445554"/>
                    </a:ext>
                  </a:extLst>
                </a:gridCol>
                <a:gridCol w="826936">
                  <a:extLst>
                    <a:ext uri="{9D8B030D-6E8A-4147-A177-3AD203B41FA5}">
                      <a16:colId xmlns:a16="http://schemas.microsoft.com/office/drawing/2014/main" val="1924859924"/>
                    </a:ext>
                  </a:extLst>
                </a:gridCol>
              </a:tblGrid>
              <a:tr h="35952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ProbeNam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 err="1">
                          <a:effectLst/>
                        </a:rPr>
                        <a:t>SystematicNam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                   </a:t>
                      </a:r>
                      <a:r>
                        <a:rPr lang="en-US" sz="1000" u="none" strike="noStrike" dirty="0" err="1">
                          <a:effectLst/>
                        </a:rPr>
                        <a:t>adj.P.Val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              B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logFC_adjusted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extLst>
                  <a:ext uri="{0D108BD9-81ED-4DB2-BD59-A6C34878D82A}">
                    <a16:rowId xmlns:a16="http://schemas.microsoft.com/office/drawing/2014/main" val="773485023"/>
                  </a:ext>
                </a:extLst>
              </a:tr>
              <a:tr h="35952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A_30_P0102096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chr17:29183003-29217681_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6.50E-0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dirty="0">
                          <a:effectLst/>
                        </a:rPr>
                        <a:t>14.27608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dirty="0">
                          <a:effectLst/>
                        </a:rPr>
                        <a:t>3.04137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extLst>
                  <a:ext uri="{0D108BD9-81ED-4DB2-BD59-A6C34878D82A}">
                    <a16:rowId xmlns:a16="http://schemas.microsoft.com/office/drawing/2014/main" val="359513783"/>
                  </a:ext>
                </a:extLst>
              </a:tr>
              <a:tr h="35952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A_30_P0102514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chr1:163528200-163528398_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64E-0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dirty="0">
                          <a:effectLst/>
                        </a:rPr>
                        <a:t>10.6733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dirty="0">
                          <a:effectLst/>
                        </a:rPr>
                        <a:t>1.62092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extLst>
                  <a:ext uri="{0D108BD9-81ED-4DB2-BD59-A6C34878D82A}">
                    <a16:rowId xmlns:a16="http://schemas.microsoft.com/office/drawing/2014/main" val="670350312"/>
                  </a:ext>
                </a:extLst>
              </a:tr>
              <a:tr h="35952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A_55_P196130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NR_04589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15E-0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3.6825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51135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extLst>
                  <a:ext uri="{0D108BD9-81ED-4DB2-BD59-A6C34878D82A}">
                    <a16:rowId xmlns:a16="http://schemas.microsoft.com/office/drawing/2014/main" val="2222413407"/>
                  </a:ext>
                </a:extLst>
              </a:tr>
              <a:tr h="35952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A_52_P9165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NR_04598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dirty="0">
                          <a:effectLst/>
                        </a:rPr>
                        <a:t>0.00092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2.82932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43516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extLst>
                  <a:ext uri="{0D108BD9-81ED-4DB2-BD59-A6C34878D82A}">
                    <a16:rowId xmlns:a16="http://schemas.microsoft.com/office/drawing/2014/main" val="4179282137"/>
                  </a:ext>
                </a:extLst>
              </a:tr>
              <a:tr h="35952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A_30_P0101903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chr19:5834117-5835940_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dirty="0">
                          <a:effectLst/>
                        </a:rPr>
                        <a:t>0.02190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dirty="0">
                          <a:effectLst/>
                        </a:rPr>
                        <a:t>-1.1477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37383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extLst>
                  <a:ext uri="{0D108BD9-81ED-4DB2-BD59-A6C34878D82A}">
                    <a16:rowId xmlns:a16="http://schemas.microsoft.com/office/drawing/2014/main" val="2730013426"/>
                  </a:ext>
                </a:extLst>
              </a:tr>
              <a:tr h="35952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A_30_P0102653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chr1:163508244-163586072_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dirty="0">
                          <a:effectLst/>
                        </a:rPr>
                        <a:t>1.13E-0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8.29167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33957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extLst>
                  <a:ext uri="{0D108BD9-81ED-4DB2-BD59-A6C34878D82A}">
                    <a16:rowId xmlns:a16="http://schemas.microsoft.com/office/drawing/2014/main" val="2102890154"/>
                  </a:ext>
                </a:extLst>
              </a:tr>
              <a:tr h="35952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A_30_P0102616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chr1:163527603-163527999_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4.86E-0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6.44963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24056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extLst>
                  <a:ext uri="{0D108BD9-81ED-4DB2-BD59-A6C34878D82A}">
                    <a16:rowId xmlns:a16="http://schemas.microsoft.com/office/drawing/2014/main" val="2878071268"/>
                  </a:ext>
                </a:extLst>
              </a:tr>
              <a:tr h="35952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A_30_P0102512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chr6:31007184-31007725_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01541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-0.6800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17361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extLst>
                  <a:ext uri="{0D108BD9-81ED-4DB2-BD59-A6C34878D82A}">
                    <a16:rowId xmlns:a16="http://schemas.microsoft.com/office/drawing/2014/main" val="2287812261"/>
                  </a:ext>
                </a:extLst>
              </a:tr>
              <a:tr h="35952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A_55_P272981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NR_02789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00494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74840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13672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extLst>
                  <a:ext uri="{0D108BD9-81ED-4DB2-BD59-A6C34878D82A}">
                    <a16:rowId xmlns:a16="http://schemas.microsoft.com/office/drawing/2014/main" val="949408327"/>
                  </a:ext>
                </a:extLst>
              </a:tr>
              <a:tr h="35952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A_55_P238424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NR_04054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01722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-0.8232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dirty="0">
                          <a:effectLst/>
                        </a:rPr>
                        <a:t>1.08389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560" marR="5560" marT="5560" marB="0" anchor="b"/>
                </a:tc>
                <a:extLst>
                  <a:ext uri="{0D108BD9-81ED-4DB2-BD59-A6C34878D82A}">
                    <a16:rowId xmlns:a16="http://schemas.microsoft.com/office/drawing/2014/main" val="1510898184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B3910F07-3C6B-419E-AD83-D066DB1058FF}"/>
              </a:ext>
            </a:extLst>
          </p:cNvPr>
          <p:cNvSpPr txBox="1"/>
          <p:nvPr/>
        </p:nvSpPr>
        <p:spPr>
          <a:xfrm>
            <a:off x="562339" y="5580819"/>
            <a:ext cx="10395407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Supplemental Table S5: Significantly up- and down-regulated </a:t>
            </a:r>
            <a:r>
              <a:rPr lang="en-US" dirty="0" err="1"/>
              <a:t>lncRNAs</a:t>
            </a:r>
            <a:r>
              <a:rPr lang="en-US" dirty="0"/>
              <a:t> that showed a linear trend across all doses. Table of up- and down-regulated linear, or dose-responsive, </a:t>
            </a:r>
            <a:r>
              <a:rPr lang="en-US" dirty="0" err="1"/>
              <a:t>lncRNAs</a:t>
            </a:r>
            <a:r>
              <a:rPr lang="en-US" dirty="0"/>
              <a:t>. </a:t>
            </a:r>
            <a:r>
              <a:rPr lang="en-US" dirty="0" err="1"/>
              <a:t>ProbeName</a:t>
            </a:r>
            <a:r>
              <a:rPr lang="en-US" dirty="0"/>
              <a:t>, Systematic Name, </a:t>
            </a:r>
            <a:r>
              <a:rPr lang="en-US" dirty="0" err="1"/>
              <a:t>Benjamini</a:t>
            </a:r>
            <a:r>
              <a:rPr lang="en-US" dirty="0"/>
              <a:t>-Hochberg adjusted p-value, B statistic, and the average log2FC across all doses are shown in each table. </a:t>
            </a:r>
          </a:p>
        </p:txBody>
      </p:sp>
    </p:spTree>
    <p:extLst>
      <p:ext uri="{BB962C8B-B14F-4D97-AF65-F5344CB8AC3E}">
        <p14:creationId xmlns:p14="http://schemas.microsoft.com/office/powerpoint/2010/main" val="36626793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807</Words>
  <Application>Microsoft Office PowerPoint</Application>
  <PresentationFormat>Widescreen</PresentationFormat>
  <Paragraphs>332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Mouse Liver Supplemental Tables 2, 4, 5 </vt:lpstr>
      <vt:lpstr>Supplemental Table S2: Top 20 most significantly up- and down-regulated genes that showed a linear trend across all doses</vt:lpstr>
      <vt:lpstr>Supplemental Table S4: MiRNAs that showed a linear trend</vt:lpstr>
      <vt:lpstr>Supplemental Table S5: Significantly up- and down-regulated lncRNAs that showed a linear trend across all dose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ouse Liver Supplemental Tables 2, 4, 5 </dc:title>
  <dc:creator>Bylicky, Michelle (NIH/NCI) [E]</dc:creator>
  <cp:lastModifiedBy>Bylicky, Michelle (NIH/NCI) [E]</cp:lastModifiedBy>
  <cp:revision>2</cp:revision>
  <dcterms:created xsi:type="dcterms:W3CDTF">2022-08-26T17:16:28Z</dcterms:created>
  <dcterms:modified xsi:type="dcterms:W3CDTF">2022-08-29T15:03:53Z</dcterms:modified>
</cp:coreProperties>
</file>